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8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4FD8B8-4D4F-F6FD-65CE-1D07C8E6C1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90D8C26-4018-DC8E-E0FE-FE1B247DE1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2BEFE1-1140-F705-E243-BA0DB7F10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089A74-DBBE-B151-EF95-BAE6DA86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B386512-007A-27AD-A2AF-34875B308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1379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A078390-E9DD-516E-705A-772E7D9BD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CF83C71-0456-3E1E-F260-FEF004918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11E9CB-3312-119D-78BF-FB5090EC8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C5EA444-72A6-C78C-47E6-0BC728C39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336E2AA-48B7-1E27-63A0-824877105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6343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A9A24FD-A1FF-2F20-F1B4-E5204B1F58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818A448-A0C9-3D4A-97F9-0E7AE342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0E98FE-9804-4F08-4048-26D9D203D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271DD6B-358F-3885-3AEE-4DC11D8ED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8FDBB1-0109-DE9E-241B-C94C7D51E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2798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956565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954E77-9543-A027-6599-BDBDD3CACC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F54AC9E-C922-4CFF-6D76-5259CF3871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9B6805C-E049-A5CC-A9E6-46AFD8ED1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8412736-44E2-E098-19F7-308BC25A2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DCD122-E70A-E00D-2E8B-5996BD9BA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2563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4F05A1-4D47-8713-6244-C9B6576D7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3134F2B-E3D1-3B48-A266-01CBDA771F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819835-4F23-43D7-D445-DE835832D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D6CEC3F-F2B0-5202-ED02-4256B05BF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001726-3958-8468-A799-8E78910CB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4826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2137BE-5FFD-ECDE-D58A-42CF81CB79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A5E08B1-C3FD-8DCE-BCEA-50AC6CC49F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B2DAA70-7305-3BAA-81E6-5E9AD7E8CB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A60687F-F62A-8F98-DEED-E0AB66A89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45FDCD8-9925-85C1-7F8F-228B16029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B75A17F-606C-7097-DE5E-A4736E572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4063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8B3D99-4989-BD38-AB01-362A9FF71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DE60EE-1603-CD34-4F5D-822DE2512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F72BA4B-A62D-49DB-9AC1-00D305EEC9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4CD4032-0730-42D1-EF35-40227CBC64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E471B30-7DEC-3566-0B50-DEF32866E4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C6325CD-39BC-8477-CBAA-F25A4851F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D7AEBAC-47D4-3ED9-6682-437A02591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0B3EA4C-C5D1-6772-F621-817230236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2164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CF8F05-3A46-D114-1B47-EDD8D73BE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34D42EA-551E-57B3-F3F9-77E4B3010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2175837-EA02-CA0F-1CE6-E8B100080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DBB8C30-A1E8-D7F1-88AB-A098D8D5F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5447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42C2B6A-A7F7-B1EC-3575-AB71CBDD5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9E95C49-5604-81A7-68A2-1F8F4C2C7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8181C66-FFA5-C1E6-7BC1-D596C5BD9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672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A42FA9-52D8-B529-E25B-8DA9BE4DF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648710E-C784-5CBC-E695-64D040A39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D8E68C1-D884-872C-4A77-A72330409C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5DB1A2-4AC6-90BA-E0A1-A00E01244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06D8F07-9823-EE8C-29B2-F86685D3F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25FD2D9-D500-38A9-29A1-21D53F116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666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6C9621-6DFA-1923-0CAF-C0722DAC41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4701E0F-9853-1885-01BC-637A3DB54D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D2DA15A-025D-8FE6-798F-2C13A9FFE9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D6ACB80-6181-E938-22E7-0510A838C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706208E-96A6-74AB-70C3-4BB8F04C3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2D2E5F3-A0DD-3C7C-DCA9-435DF4F93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8188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13F457C-D02A-0501-481A-82FB1B091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2C2B73A-45E8-92EE-DD73-C49417BABB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4866BF-5A82-4B4C-3F0D-75567B5553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B99D0-3F2A-4530-9E4F-0BD38AC4FE63}" type="datetimeFigureOut">
              <a:rPr lang="it-IT" smtClean="0"/>
              <a:t>11/06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B180ECE-B2BE-418E-F6F8-789A73D74A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10E78D-EEC4-D771-7E5C-2FAA833005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C5987D-EA55-470A-A50A-E6CA4CFFF8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8006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41832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ssociation between lifestyle modifications and improvement of early cardiac damage in children and adolescents with excess weight and/or high blood pressur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23481"/>
            <a:ext cx="119153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</a:rPr>
              <a:t>Lifestyle modifications may improve cardiac damage in children with increased weight and/or blood pressure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       </a:t>
            </a:r>
            <a:r>
              <a:rPr lang="en-GB" sz="2000" dirty="0">
                <a:solidFill>
                  <a:srgbClr val="0065AA"/>
                </a:solidFill>
              </a:rPr>
              <a:t>278 children/adolescents, 10.6 (2.3) year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Genoves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1600" y="5600956"/>
            <a:ext cx="7366000" cy="16773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2000" b="1" dirty="0">
                <a:solidFill>
                  <a:schemeClr val="bg1"/>
                </a:solidFill>
              </a:rPr>
              <a:t>CONCLUSION</a:t>
            </a:r>
            <a:r>
              <a:rPr lang="en-GB" sz="2000" dirty="0">
                <a:solidFill>
                  <a:schemeClr val="bg1"/>
                </a:solidFill>
              </a:rPr>
              <a:t>: </a:t>
            </a:r>
            <a:r>
              <a:rPr lang="en-US" sz="2000" b="1" dirty="0">
                <a:solidFill>
                  <a:schemeClr val="bg1"/>
                </a:solidFill>
              </a:rPr>
              <a:t>In a pediatric population at cardiovascular risk changing incorrect lifestyle and dietary habits is associated with both reduction of BMI and BP values, and regression of early cardiac damage</a:t>
            </a:r>
            <a:r>
              <a:rPr lang="en-US" b="1" dirty="0">
                <a:solidFill>
                  <a:schemeClr val="bg1"/>
                </a:solidFill>
              </a:rPr>
              <a:t>. </a:t>
            </a:r>
            <a:r>
              <a:rPr lang="en-GB" b="1" dirty="0">
                <a:solidFill>
                  <a:schemeClr val="bg1"/>
                </a:solidFill>
              </a:rPr>
              <a:t> </a:t>
            </a:r>
            <a:r>
              <a:rPr lang="en-GB" dirty="0">
                <a:solidFill>
                  <a:schemeClr val="bg1"/>
                </a:solidFill>
              </a:rPr>
              <a:t>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Rectangle 19">
            <a:extLst>
              <a:ext uri="{FF2B5EF4-FFF2-40B4-BE49-F238E27FC236}">
                <a16:creationId xmlns:a16="http://schemas.microsoft.com/office/drawing/2014/main" id="{F8B38C85-94D5-1A9B-79E3-10E68DDDF454}"/>
              </a:ext>
            </a:extLst>
          </p:cNvPr>
          <p:cNvSpPr/>
          <p:nvPr/>
        </p:nvSpPr>
        <p:spPr>
          <a:xfrm>
            <a:off x="178280" y="2359428"/>
            <a:ext cx="1735313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33.1% HT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9C1A5B0-009B-0F5A-3D3D-FBBED3299758}"/>
              </a:ext>
            </a:extLst>
          </p:cNvPr>
          <p:cNvSpPr/>
          <p:nvPr/>
        </p:nvSpPr>
        <p:spPr>
          <a:xfrm>
            <a:off x="178280" y="3256062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52.9% OB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578DD14A-FC65-4A7F-ABFF-94C1F5BC9442}"/>
              </a:ext>
            </a:extLst>
          </p:cNvPr>
          <p:cNvSpPr/>
          <p:nvPr/>
        </p:nvSpPr>
        <p:spPr>
          <a:xfrm>
            <a:off x="168629" y="4213097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36.3% LVH</a:t>
            </a:r>
          </a:p>
        </p:txBody>
      </p:sp>
      <p:sp>
        <p:nvSpPr>
          <p:cNvPr id="6" name="Rectangle 58">
            <a:extLst>
              <a:ext uri="{FF2B5EF4-FFF2-40B4-BE49-F238E27FC236}">
                <a16:creationId xmlns:a16="http://schemas.microsoft.com/office/drawing/2014/main" id="{34525A4F-85EF-667B-FFC4-C7135CF5067C}"/>
              </a:ext>
            </a:extLst>
          </p:cNvPr>
          <p:cNvSpPr/>
          <p:nvPr/>
        </p:nvSpPr>
        <p:spPr>
          <a:xfrm>
            <a:off x="2916943" y="2204410"/>
            <a:ext cx="1735313" cy="285106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rgbClr val="AA0065"/>
                </a:solidFill>
              </a:rPr>
              <a:t>Non-pharmacological treatment, based on correcting unhealthy lifestyles and improving dietary habits</a:t>
            </a:r>
            <a:endParaRPr lang="en-GB" sz="2000" b="1" dirty="0">
              <a:solidFill>
                <a:srgbClr val="AA0065"/>
              </a:solidFill>
            </a:endParaRPr>
          </a:p>
        </p:txBody>
      </p:sp>
      <p:cxnSp>
        <p:nvCxnSpPr>
          <p:cNvPr id="8" name="Straight Arrow Connector 46">
            <a:extLst>
              <a:ext uri="{FF2B5EF4-FFF2-40B4-BE49-F238E27FC236}">
                <a16:creationId xmlns:a16="http://schemas.microsoft.com/office/drawing/2014/main" id="{02BA7B58-52AB-168D-16C5-DE47B52C0AE8}"/>
              </a:ext>
            </a:extLst>
          </p:cNvPr>
          <p:cNvCxnSpPr>
            <a:cxnSpLocks/>
          </p:cNvCxnSpPr>
          <p:nvPr/>
        </p:nvCxnSpPr>
        <p:spPr>
          <a:xfrm>
            <a:off x="1913593" y="2684000"/>
            <a:ext cx="1003350" cy="77374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3">
            <a:extLst>
              <a:ext uri="{FF2B5EF4-FFF2-40B4-BE49-F238E27FC236}">
                <a16:creationId xmlns:a16="http://schemas.microsoft.com/office/drawing/2014/main" id="{04358DD7-B6D6-FB8B-FC26-17B13C796B0D}"/>
              </a:ext>
            </a:extLst>
          </p:cNvPr>
          <p:cNvCxnSpPr>
            <a:cxnSpLocks/>
            <a:stCxn id="4" idx="3"/>
            <a:endCxn id="6" idx="1"/>
          </p:cNvCxnSpPr>
          <p:nvPr/>
        </p:nvCxnSpPr>
        <p:spPr>
          <a:xfrm>
            <a:off x="1913593" y="3567483"/>
            <a:ext cx="1003350" cy="6246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36">
            <a:extLst>
              <a:ext uri="{FF2B5EF4-FFF2-40B4-BE49-F238E27FC236}">
                <a16:creationId xmlns:a16="http://schemas.microsoft.com/office/drawing/2014/main" id="{8819DE92-C0C6-C3F3-E382-334CEDC5AA4B}"/>
              </a:ext>
            </a:extLst>
          </p:cNvPr>
          <p:cNvCxnSpPr>
            <a:cxnSpLocks/>
            <a:stCxn id="5" idx="3"/>
          </p:cNvCxnSpPr>
          <p:nvPr/>
        </p:nvCxnSpPr>
        <p:spPr>
          <a:xfrm flipV="1">
            <a:off x="1897014" y="3719976"/>
            <a:ext cx="982133" cy="802653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48">
            <a:extLst>
              <a:ext uri="{FF2B5EF4-FFF2-40B4-BE49-F238E27FC236}">
                <a16:creationId xmlns:a16="http://schemas.microsoft.com/office/drawing/2014/main" id="{8BB523D7-94C7-42F0-BFC8-4D363A335535}"/>
              </a:ext>
            </a:extLst>
          </p:cNvPr>
          <p:cNvSpPr/>
          <p:nvPr/>
        </p:nvSpPr>
        <p:spPr>
          <a:xfrm>
            <a:off x="5567511" y="2372326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18.7% HT</a:t>
            </a:r>
          </a:p>
        </p:txBody>
      </p:sp>
      <p:sp>
        <p:nvSpPr>
          <p:cNvPr id="23" name="Rectangle 38">
            <a:extLst>
              <a:ext uri="{FF2B5EF4-FFF2-40B4-BE49-F238E27FC236}">
                <a16:creationId xmlns:a16="http://schemas.microsoft.com/office/drawing/2014/main" id="{418CA497-88F7-D28C-DB14-D0A056ADE224}"/>
              </a:ext>
            </a:extLst>
          </p:cNvPr>
          <p:cNvSpPr/>
          <p:nvPr/>
        </p:nvSpPr>
        <p:spPr>
          <a:xfrm>
            <a:off x="5546491" y="3254012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30.2% OB</a:t>
            </a:r>
          </a:p>
        </p:txBody>
      </p:sp>
      <p:sp>
        <p:nvSpPr>
          <p:cNvPr id="33" name="Rectangle 39">
            <a:extLst>
              <a:ext uri="{FF2B5EF4-FFF2-40B4-BE49-F238E27FC236}">
                <a16:creationId xmlns:a16="http://schemas.microsoft.com/office/drawing/2014/main" id="{A9EAE9A5-7AE5-F3C1-BD48-5A641D92D7C1}"/>
              </a:ext>
            </a:extLst>
          </p:cNvPr>
          <p:cNvSpPr/>
          <p:nvPr/>
        </p:nvSpPr>
        <p:spPr>
          <a:xfrm>
            <a:off x="5538181" y="4154420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22.3% LVH</a:t>
            </a:r>
          </a:p>
        </p:txBody>
      </p:sp>
      <p:cxnSp>
        <p:nvCxnSpPr>
          <p:cNvPr id="34" name="Straight Arrow Connector 46">
            <a:extLst>
              <a:ext uri="{FF2B5EF4-FFF2-40B4-BE49-F238E27FC236}">
                <a16:creationId xmlns:a16="http://schemas.microsoft.com/office/drawing/2014/main" id="{C1EA7F14-8E49-B628-9E36-2E47198BE91F}"/>
              </a:ext>
            </a:extLst>
          </p:cNvPr>
          <p:cNvCxnSpPr>
            <a:cxnSpLocks/>
            <a:endCxn id="22" idx="1"/>
          </p:cNvCxnSpPr>
          <p:nvPr/>
        </p:nvCxnSpPr>
        <p:spPr>
          <a:xfrm flipV="1">
            <a:off x="4728937" y="2683747"/>
            <a:ext cx="838574" cy="77954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F045E47-2FFD-85F4-E923-68877CDFCF61}"/>
              </a:ext>
            </a:extLst>
          </p:cNvPr>
          <p:cNvCxnSpPr>
            <a:cxnSpLocks/>
            <a:endCxn id="33" idx="1"/>
          </p:cNvCxnSpPr>
          <p:nvPr/>
        </p:nvCxnSpPr>
        <p:spPr>
          <a:xfrm>
            <a:off x="4690052" y="3689914"/>
            <a:ext cx="848129" cy="77592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A893A9A2-9A4F-0CDE-35F1-ECF2EAA669F0}"/>
              </a:ext>
            </a:extLst>
          </p:cNvPr>
          <p:cNvSpPr txBox="1"/>
          <p:nvPr/>
        </p:nvSpPr>
        <p:spPr>
          <a:xfrm>
            <a:off x="89451" y="5214433"/>
            <a:ext cx="121919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400" b="1" dirty="0">
                <a:solidFill>
                  <a:srgbClr val="0092F7"/>
                </a:solidFill>
              </a:rPr>
              <a:t>HT: </a:t>
            </a:r>
            <a:r>
              <a:rPr lang="it-IT" sz="1400" b="1" dirty="0" err="1">
                <a:solidFill>
                  <a:srgbClr val="0092F7"/>
                </a:solidFill>
              </a:rPr>
              <a:t>hypertension</a:t>
            </a:r>
            <a:r>
              <a:rPr lang="it-IT" sz="1400" b="1" dirty="0">
                <a:solidFill>
                  <a:srgbClr val="0092F7"/>
                </a:solidFill>
              </a:rPr>
              <a:t>, OB: </a:t>
            </a:r>
            <a:r>
              <a:rPr lang="it-IT" sz="1400" b="1" dirty="0" err="1">
                <a:solidFill>
                  <a:srgbClr val="0092F7"/>
                </a:solidFill>
              </a:rPr>
              <a:t>obesity</a:t>
            </a:r>
            <a:r>
              <a:rPr lang="it-IT" sz="1400" b="1" dirty="0">
                <a:solidFill>
                  <a:srgbClr val="0092F7"/>
                </a:solidFill>
              </a:rPr>
              <a:t>, OW: </a:t>
            </a:r>
            <a:r>
              <a:rPr lang="it-IT" sz="1400" b="1" dirty="0" err="1">
                <a:solidFill>
                  <a:srgbClr val="0092F7"/>
                </a:solidFill>
              </a:rPr>
              <a:t>overweight</a:t>
            </a:r>
            <a:r>
              <a:rPr lang="it-IT" sz="1400" b="1" dirty="0">
                <a:solidFill>
                  <a:srgbClr val="0092F7"/>
                </a:solidFill>
              </a:rPr>
              <a:t> LVH: </a:t>
            </a:r>
            <a:r>
              <a:rPr lang="it-IT" sz="1400" b="1" dirty="0" err="1">
                <a:solidFill>
                  <a:srgbClr val="0092F7"/>
                </a:solidFill>
              </a:rPr>
              <a:t>left</a:t>
            </a:r>
            <a:r>
              <a:rPr lang="it-IT" sz="1400" b="1" dirty="0">
                <a:solidFill>
                  <a:srgbClr val="0092F7"/>
                </a:solidFill>
              </a:rPr>
              <a:t> </a:t>
            </a:r>
            <a:r>
              <a:rPr lang="it-IT" sz="1400" b="1" dirty="0" err="1">
                <a:solidFill>
                  <a:srgbClr val="0092F7"/>
                </a:solidFill>
              </a:rPr>
              <a:t>ventricular</a:t>
            </a:r>
            <a:r>
              <a:rPr lang="it-IT" sz="1400" b="1" dirty="0">
                <a:solidFill>
                  <a:srgbClr val="0092F7"/>
                </a:solidFill>
              </a:rPr>
              <a:t> </a:t>
            </a:r>
            <a:r>
              <a:rPr lang="it-IT" sz="1400" b="1" dirty="0" err="1">
                <a:solidFill>
                  <a:srgbClr val="0092F7"/>
                </a:solidFill>
              </a:rPr>
              <a:t>hypertrophy</a:t>
            </a:r>
            <a:r>
              <a:rPr lang="it-IT" sz="1400" b="1" dirty="0">
                <a:solidFill>
                  <a:srgbClr val="0092F7"/>
                </a:solidFill>
              </a:rPr>
              <a:t>, LVMI: </a:t>
            </a:r>
            <a:r>
              <a:rPr lang="it-IT" sz="1400" b="1" dirty="0" err="1">
                <a:solidFill>
                  <a:srgbClr val="0092F7"/>
                </a:solidFill>
              </a:rPr>
              <a:t>left</a:t>
            </a:r>
            <a:r>
              <a:rPr lang="it-IT" sz="1400" b="1" dirty="0">
                <a:solidFill>
                  <a:srgbClr val="0092F7"/>
                </a:solidFill>
              </a:rPr>
              <a:t> </a:t>
            </a:r>
            <a:r>
              <a:rPr lang="it-IT" sz="1400" b="1" dirty="0" err="1">
                <a:solidFill>
                  <a:srgbClr val="0092F7"/>
                </a:solidFill>
              </a:rPr>
              <a:t>ventricular</a:t>
            </a:r>
            <a:r>
              <a:rPr lang="it-IT" sz="1400" b="1" dirty="0">
                <a:solidFill>
                  <a:srgbClr val="0092F7"/>
                </a:solidFill>
              </a:rPr>
              <a:t> mass index </a:t>
            </a:r>
          </a:p>
        </p:txBody>
      </p:sp>
      <p:cxnSp>
        <p:nvCxnSpPr>
          <p:cNvPr id="58" name="Straight Arrow Connector 13">
            <a:extLst>
              <a:ext uri="{FF2B5EF4-FFF2-40B4-BE49-F238E27FC236}">
                <a16:creationId xmlns:a16="http://schemas.microsoft.com/office/drawing/2014/main" id="{5018E41E-2A70-2C01-03C5-EAF84FAA546B}"/>
              </a:ext>
            </a:extLst>
          </p:cNvPr>
          <p:cNvCxnSpPr>
            <a:cxnSpLocks/>
          </p:cNvCxnSpPr>
          <p:nvPr/>
        </p:nvCxnSpPr>
        <p:spPr>
          <a:xfrm>
            <a:off x="4652256" y="3576602"/>
            <a:ext cx="867656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Immagin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7600" y="1737721"/>
            <a:ext cx="4447714" cy="3459333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457356" y="4876630"/>
            <a:ext cx="1177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1"/>
                </a:solidFill>
              </a:rPr>
              <a:t>Baseline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5696605" y="4890642"/>
            <a:ext cx="1511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1"/>
                </a:solidFill>
              </a:rPr>
              <a:t>Follow-up</a:t>
            </a:r>
          </a:p>
        </p:txBody>
      </p:sp>
    </p:spTree>
    <p:extLst>
      <p:ext uri="{BB962C8B-B14F-4D97-AF65-F5344CB8AC3E}">
        <p14:creationId xmlns:p14="http://schemas.microsoft.com/office/powerpoint/2010/main" val="2572194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4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7</cp:revision>
  <dcterms:created xsi:type="dcterms:W3CDTF">2023-04-07T17:18:21Z</dcterms:created>
  <dcterms:modified xsi:type="dcterms:W3CDTF">2023-06-11T11:17:21Z</dcterms:modified>
</cp:coreProperties>
</file>